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59" r:id="rId2"/>
    <p:sldId id="276" r:id="rId3"/>
    <p:sldId id="284" r:id="rId4"/>
    <p:sldId id="286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7" name="Liu, Yunlong" initials="LY [7]" lastIdx="1" clrIdx="6">
    <p:extLst/>
  </p:cmAuthor>
  <p:cmAuthor id="1" name="Liu, Yunlong" initials="LY" lastIdx="1" clrIdx="0">
    <p:extLst/>
  </p:cmAuthor>
  <p:cmAuthor id="8" name="Liu, Yunlong" initials="LY [8]" lastIdx="1" clrIdx="7">
    <p:extLst/>
  </p:cmAuthor>
  <p:cmAuthor id="2" name="Liu, Yunlong" initials="LY [2]" lastIdx="1" clrIdx="1">
    <p:extLst/>
  </p:cmAuthor>
  <p:cmAuthor id="3" name="Liu, Yunlong" initials="LY [3]" lastIdx="1" clrIdx="2">
    <p:extLst/>
  </p:cmAuthor>
  <p:cmAuthor id="4" name="Liu, Yunlong" initials="LY [4]" lastIdx="1" clrIdx="3">
    <p:extLst/>
  </p:cmAuthor>
  <p:cmAuthor id="5" name="Liu, Yunlong" initials="LY [5]" lastIdx="1" clrIdx="4">
    <p:extLst/>
  </p:cmAuthor>
  <p:cmAuthor id="6" name="Liu, Yunlong" initials="LY [6]" lastIdx="1" clrIdx="5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826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3088" y="17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7" Type="http://schemas.openxmlformats.org/officeDocument/2006/relationships/commentAuthors" Target="commentAuthors.xml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B15BBAE-87DE-4C74-8C17-01E0D69A21EF}" type="datetimeFigureOut">
              <a:rPr lang="en-US" smtClean="0"/>
              <a:t>1/8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B80658-30F2-4DA7-B9E7-DCE253FBDD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97661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2CF6E-02BA-46B9-B544-5626B908A52F}" type="datetimeFigureOut">
              <a:rPr lang="en-US" smtClean="0"/>
              <a:t>1/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23E48-35A5-41C2-A49A-5BDEF0F4F7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40485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2CF6E-02BA-46B9-B544-5626B908A52F}" type="datetimeFigureOut">
              <a:rPr lang="en-US" smtClean="0"/>
              <a:t>1/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23E48-35A5-41C2-A49A-5BDEF0F4F7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873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2CF6E-02BA-46B9-B544-5626B908A52F}" type="datetimeFigureOut">
              <a:rPr lang="en-US" smtClean="0"/>
              <a:t>1/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23E48-35A5-41C2-A49A-5BDEF0F4F7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3540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2CF6E-02BA-46B9-B544-5626B908A52F}" type="datetimeFigureOut">
              <a:rPr lang="en-US" smtClean="0"/>
              <a:t>1/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23E48-35A5-41C2-A49A-5BDEF0F4F7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7932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2CF6E-02BA-46B9-B544-5626B908A52F}" type="datetimeFigureOut">
              <a:rPr lang="en-US" smtClean="0"/>
              <a:t>1/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23E48-35A5-41C2-A49A-5BDEF0F4F7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96174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2CF6E-02BA-46B9-B544-5626B908A52F}" type="datetimeFigureOut">
              <a:rPr lang="en-US" smtClean="0"/>
              <a:t>1/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23E48-35A5-41C2-A49A-5BDEF0F4F7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579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2CF6E-02BA-46B9-B544-5626B908A52F}" type="datetimeFigureOut">
              <a:rPr lang="en-US" smtClean="0"/>
              <a:t>1/8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23E48-35A5-41C2-A49A-5BDEF0F4F7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22020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2CF6E-02BA-46B9-B544-5626B908A52F}" type="datetimeFigureOut">
              <a:rPr lang="en-US" smtClean="0"/>
              <a:t>1/8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23E48-35A5-41C2-A49A-5BDEF0F4F7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98037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2CF6E-02BA-46B9-B544-5626B908A52F}" type="datetimeFigureOut">
              <a:rPr lang="en-US" smtClean="0"/>
              <a:t>1/8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23E48-35A5-41C2-A49A-5BDEF0F4F7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8078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2CF6E-02BA-46B9-B544-5626B908A52F}" type="datetimeFigureOut">
              <a:rPr lang="en-US" smtClean="0"/>
              <a:t>1/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23E48-35A5-41C2-A49A-5BDEF0F4F7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04760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D2CF6E-02BA-46B9-B544-5626B908A52F}" type="datetimeFigureOut">
              <a:rPr lang="en-US" smtClean="0"/>
              <a:t>1/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23E48-35A5-41C2-A49A-5BDEF0F4F7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65183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D2CF6E-02BA-46B9-B544-5626B908A52F}" type="datetimeFigureOut">
              <a:rPr lang="en-US" smtClean="0"/>
              <a:t>1/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023E48-35A5-41C2-A49A-5BDEF0F4F7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68841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2" name="Picture 151">
            <a:extLst>
              <a:ext uri="{FF2B5EF4-FFF2-40B4-BE49-F238E27FC236}">
                <a16:creationId xmlns:a16="http://schemas.microsoft.com/office/drawing/2014/main" xmlns="" id="{E854972F-D7B1-4D1F-8CC8-23AB97DA5C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0396" y="2567772"/>
            <a:ext cx="6389649" cy="3042064"/>
          </a:xfrm>
          <a:prstGeom prst="rect">
            <a:avLst/>
          </a:prstGeom>
        </p:spPr>
      </p:pic>
      <p:sp>
        <p:nvSpPr>
          <p:cNvPr id="153" name="TextBox 152">
            <a:extLst>
              <a:ext uri="{FF2B5EF4-FFF2-40B4-BE49-F238E27FC236}">
                <a16:creationId xmlns:a16="http://schemas.microsoft.com/office/drawing/2014/main" xmlns="" id="{551D557B-4320-4253-B7C7-D2A55B7235F6}"/>
              </a:ext>
            </a:extLst>
          </p:cNvPr>
          <p:cNvSpPr txBox="1"/>
          <p:nvPr/>
        </p:nvSpPr>
        <p:spPr>
          <a:xfrm>
            <a:off x="702527" y="8151541"/>
            <a:ext cx="16850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 Figure 1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2213147" y="396161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Supplementary Figures</a:t>
            </a:r>
          </a:p>
        </p:txBody>
      </p:sp>
    </p:spTree>
    <p:extLst>
      <p:ext uri="{BB962C8B-B14F-4D97-AF65-F5344CB8AC3E}">
        <p14:creationId xmlns:p14="http://schemas.microsoft.com/office/powerpoint/2010/main" val="29994510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7F60CEF-FF88-4CEB-A568-0DCA526B92B3}"/>
              </a:ext>
            </a:extLst>
          </p:cNvPr>
          <p:cNvSpPr txBox="1">
            <a:spLocks/>
          </p:cNvSpPr>
          <p:nvPr/>
        </p:nvSpPr>
        <p:spPr>
          <a:xfrm>
            <a:off x="320126" y="8331956"/>
            <a:ext cx="6217748" cy="478539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dirty="0">
                <a:solidFill>
                  <a:prstClr val="black"/>
                </a:solidFill>
              </a:rPr>
              <a:t>Suppl Figure 2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xmlns="" id="{6D1AA75B-FDBD-4318-8F0D-5C40908C39E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1710" y="5458927"/>
            <a:ext cx="2286005" cy="2286005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xmlns="" id="{8F04AA4D-EECA-40B5-B29F-240DCD14FFA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1711" y="693371"/>
            <a:ext cx="2286005" cy="2286005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xmlns="" id="{9433858C-E338-4831-99A8-0D6B01542BD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1710" y="3076148"/>
            <a:ext cx="2286005" cy="22860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20273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888A64BB-751B-4DD4-8E85-6A47A7FA792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2995" y="2285994"/>
            <a:ext cx="4572009" cy="4572009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43032ED4-3871-47D2-ABB4-65491E36B438}"/>
              </a:ext>
            </a:extLst>
          </p:cNvPr>
          <p:cNvSpPr txBox="1"/>
          <p:nvPr/>
        </p:nvSpPr>
        <p:spPr>
          <a:xfrm>
            <a:off x="702527" y="8140390"/>
            <a:ext cx="16850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 Figure 3</a:t>
            </a:r>
          </a:p>
        </p:txBody>
      </p:sp>
    </p:spTree>
    <p:extLst>
      <p:ext uri="{BB962C8B-B14F-4D97-AF65-F5344CB8AC3E}">
        <p14:creationId xmlns:p14="http://schemas.microsoft.com/office/powerpoint/2010/main" val="12289640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80449540-8BB4-4835-B069-73FE455508C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1031" y="732728"/>
            <a:ext cx="3657607" cy="365760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D42EB093-896A-452E-B3E8-3E8B28500290}"/>
              </a:ext>
            </a:extLst>
          </p:cNvPr>
          <p:cNvSpPr txBox="1"/>
          <p:nvPr/>
        </p:nvSpPr>
        <p:spPr>
          <a:xfrm>
            <a:off x="363728" y="8106002"/>
            <a:ext cx="16850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 Figure 4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1447594" y="641897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447594" y="1766256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447594" y="289061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8457891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736</TotalTime>
  <Words>17</Words>
  <Application>Microsoft Macintosh PowerPoint</Application>
  <PresentationFormat>Letter Paper (8.5x11 in)</PresentationFormat>
  <Paragraphs>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Calibri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3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n, Andy B</dc:creator>
  <cp:lastModifiedBy>Liu, Yunlong</cp:lastModifiedBy>
  <cp:revision>71</cp:revision>
  <dcterms:created xsi:type="dcterms:W3CDTF">2018-11-30T14:38:10Z</dcterms:created>
  <dcterms:modified xsi:type="dcterms:W3CDTF">2019-01-08T12:36:46Z</dcterms:modified>
</cp:coreProperties>
</file>